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052" y="0"/>
            <a:ext cx="3027363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E0DAF0-4CF9-414D-A3B4-D85ECEA807B7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08025" y="1160463"/>
            <a:ext cx="5568950" cy="31337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67227"/>
            <a:ext cx="5588000" cy="36560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8565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052" y="8818565"/>
            <a:ext cx="3027363" cy="4651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28605D-0374-4D7C-93C6-B8C2CAF2E6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907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428605D-0374-4D7C-93C6-B8C2CAF2E6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4696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52212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613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33703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999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21599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408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494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692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900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128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95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DBCC4D-52D4-4D5A-B25C-7BB69AC17770}" type="datetimeFigureOut">
              <a:rPr lang="en-US" smtClean="0"/>
              <a:t>4/2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59B2A-3D10-42D2-A8DA-0023B81B85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710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3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wmf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5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9.jpeg"/><Relationship Id="rId5" Type="http://schemas.openxmlformats.org/officeDocument/2006/relationships/image" Target="../media/image1.wmf"/><Relationship Id="rId15" Type="http://schemas.openxmlformats.org/officeDocument/2006/relationships/image" Target="../media/image4.emf"/><Relationship Id="rId10" Type="http://schemas.openxmlformats.org/officeDocument/2006/relationships/image" Target="../media/image8.jpeg"/><Relationship Id="rId4" Type="http://schemas.openxmlformats.org/officeDocument/2006/relationships/oleObject" Target="../embeddings/oleObject1.bin"/><Relationship Id="rId9" Type="http://schemas.openxmlformats.org/officeDocument/2006/relationships/image" Target="../media/image7.png"/><Relationship Id="rId1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Text Box 26"/>
          <p:cNvSpPr txBox="1">
            <a:spLocks noChangeAspect="1" noChangeArrowheads="1"/>
          </p:cNvSpPr>
          <p:nvPr/>
        </p:nvSpPr>
        <p:spPr bwMode="auto">
          <a:xfrm>
            <a:off x="221773" y="86220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911897" y="4648698"/>
            <a:ext cx="18865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</a:t>
            </a:r>
            <a:r>
              <a:rPr lang="en-US" dirty="0" smtClean="0"/>
              <a:t> 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overexpressio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67142" y="4697068"/>
            <a:ext cx="959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6840504"/>
              </p:ext>
            </p:extLst>
          </p:nvPr>
        </p:nvGraphicFramePr>
        <p:xfrm>
          <a:off x="1748276" y="1049750"/>
          <a:ext cx="1752561" cy="3876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5" r:id="rId4" imgW="541440" imgH="166680" progId="">
                  <p:embed/>
                </p:oleObj>
              </mc:Choice>
              <mc:Fallback>
                <p:oleObj r:id="rId4" imgW="541440" imgH="1666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48276" y="1049750"/>
                        <a:ext cx="1752561" cy="387692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2815990"/>
              </p:ext>
            </p:extLst>
          </p:nvPr>
        </p:nvGraphicFramePr>
        <p:xfrm>
          <a:off x="1748276" y="1486494"/>
          <a:ext cx="1752561" cy="3974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6" r:id="rId6" imgW="632880" imgH="178200" progId="">
                  <p:embed/>
                </p:oleObj>
              </mc:Choice>
              <mc:Fallback>
                <p:oleObj r:id="rId6" imgW="632880" imgH="17820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748276" y="1486494"/>
                        <a:ext cx="1752561" cy="397464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8" name="TextBox 77"/>
          <p:cNvSpPr txBox="1"/>
          <p:nvPr/>
        </p:nvSpPr>
        <p:spPr>
          <a:xfrm rot="19390617">
            <a:off x="1929883" y="377905"/>
            <a:ext cx="9861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9522181">
            <a:off x="2789012" y="184406"/>
            <a:ext cx="164630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overexpressio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xmlns="" id="{E137165D-52FA-4B25-A012-E5A3C18ED862}"/>
              </a:ext>
            </a:extLst>
          </p:cNvPr>
          <p:cNvCxnSpPr>
            <a:cxnSpLocks/>
          </p:cNvCxnSpPr>
          <p:nvPr/>
        </p:nvCxnSpPr>
        <p:spPr>
          <a:xfrm>
            <a:off x="3508140" y="1703370"/>
            <a:ext cx="820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1184EB03-B2F6-4003-B078-0E05CA8EE781}"/>
              </a:ext>
            </a:extLst>
          </p:cNvPr>
          <p:cNvSpPr txBox="1"/>
          <p:nvPr/>
        </p:nvSpPr>
        <p:spPr>
          <a:xfrm>
            <a:off x="3622913" y="1514208"/>
            <a:ext cx="581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6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xmlns="" id="{84BBDD68-D76B-4885-A6A3-930684220256}"/>
              </a:ext>
            </a:extLst>
          </p:cNvPr>
          <p:cNvSpPr txBox="1"/>
          <p:nvPr/>
        </p:nvSpPr>
        <p:spPr>
          <a:xfrm>
            <a:off x="497031" y="1071041"/>
            <a:ext cx="1447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xmlns="" id="{3D7ABD65-9281-4D6D-B5C5-D85904E57DA2}"/>
              </a:ext>
            </a:extLst>
          </p:cNvPr>
          <p:cNvCxnSpPr>
            <a:cxnSpLocks/>
          </p:cNvCxnSpPr>
          <p:nvPr/>
        </p:nvCxnSpPr>
        <p:spPr>
          <a:xfrm>
            <a:off x="3498957" y="1079478"/>
            <a:ext cx="8209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xmlns="" id="{7949B91A-2E64-4D61-A0A5-CCAFE4FA1270}"/>
              </a:ext>
            </a:extLst>
          </p:cNvPr>
          <p:cNvSpPr txBox="1"/>
          <p:nvPr/>
        </p:nvSpPr>
        <p:spPr>
          <a:xfrm>
            <a:off x="3555177" y="886344"/>
            <a:ext cx="581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30</a:t>
            </a:r>
          </a:p>
        </p:txBody>
      </p:sp>
      <p:sp>
        <p:nvSpPr>
          <p:cNvPr id="87" name="Rectangle 86"/>
          <p:cNvSpPr/>
          <p:nvPr/>
        </p:nvSpPr>
        <p:spPr>
          <a:xfrm>
            <a:off x="739948" y="1503912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xmlns="" id="{89C2831D-B01C-4109-A62D-350C442A762F}"/>
              </a:ext>
            </a:extLst>
          </p:cNvPr>
          <p:cNvSpPr txBox="1"/>
          <p:nvPr/>
        </p:nvSpPr>
        <p:spPr>
          <a:xfrm>
            <a:off x="3561831" y="663000"/>
            <a:ext cx="581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kDA</a:t>
            </a:r>
            <a:endParaRPr lang="en-US" dirty="0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24120" y="2689968"/>
            <a:ext cx="2438400" cy="18288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 rot="5400000">
            <a:off x="7773930" y="2695601"/>
            <a:ext cx="2438400" cy="1828800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>
            <a:off x="9446829" y="4708925"/>
            <a:ext cx="33469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9915681" y="142904"/>
            <a:ext cx="10651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748698" y="485000"/>
            <a:ext cx="175160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Bef>
                <a:spcPts val="600"/>
              </a:spcBef>
            </a:pP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overexpressio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9215586" y="3297527"/>
            <a:ext cx="1885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ell area (μm</a:t>
            </a:r>
            <a:r>
              <a:rPr lang="en-US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Picture 2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245054" y="2565200"/>
            <a:ext cx="2438400" cy="18288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1607097" y="2563468"/>
            <a:ext cx="2438400" cy="1828800"/>
          </a:xfrm>
          <a:prstGeom prst="rect">
            <a:avLst/>
          </a:prstGeom>
        </p:spPr>
      </p:pic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5804279"/>
              </p:ext>
            </p:extLst>
          </p:nvPr>
        </p:nvGraphicFramePr>
        <p:xfrm>
          <a:off x="7032056" y="241787"/>
          <a:ext cx="2917825" cy="1786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7" name="Prism 9" r:id="rId12" imgW="2918180" imgH="2453009" progId="Prism9.Document">
                  <p:embed/>
                </p:oleObj>
              </mc:Choice>
              <mc:Fallback>
                <p:oleObj name="Prism 9" r:id="rId12" imgW="2918180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032056" y="241787"/>
                        <a:ext cx="2917825" cy="1786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TextBox 30"/>
          <p:cNvSpPr txBox="1"/>
          <p:nvPr/>
        </p:nvSpPr>
        <p:spPr>
          <a:xfrm rot="16200000">
            <a:off x="6151754" y="793538"/>
            <a:ext cx="1625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ells number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2370849"/>
              </p:ext>
            </p:extLst>
          </p:nvPr>
        </p:nvGraphicFramePr>
        <p:xfrm>
          <a:off x="10220681" y="2583204"/>
          <a:ext cx="2193469" cy="20586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8" name="Prism 9" r:id="rId14" imgW="2076543" imgH="2453009" progId="Prism9.Document">
                  <p:embed/>
                </p:oleObj>
              </mc:Choice>
              <mc:Fallback>
                <p:oleObj name="Prism 9" r:id="rId14" imgW="2076543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0220681" y="2583204"/>
                        <a:ext cx="2193469" cy="20586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" name="Rectangle 34"/>
          <p:cNvSpPr/>
          <p:nvPr/>
        </p:nvSpPr>
        <p:spPr>
          <a:xfrm>
            <a:off x="9810417" y="238158"/>
            <a:ext cx="183001" cy="148046"/>
          </a:xfrm>
          <a:prstGeom prst="rect">
            <a:avLst/>
          </a:prstGeom>
          <a:solidFill>
            <a:srgbClr val="0000FF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9810418" y="600622"/>
            <a:ext cx="183001" cy="148046"/>
          </a:xfrm>
          <a:prstGeom prst="rect">
            <a:avLst/>
          </a:prstGeom>
          <a:solidFill>
            <a:srgbClr val="F9404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 Box 26"/>
          <p:cNvSpPr txBox="1">
            <a:spLocks noChangeAspect="1" noChangeArrowheads="1"/>
          </p:cNvSpPr>
          <p:nvPr/>
        </p:nvSpPr>
        <p:spPr bwMode="auto">
          <a:xfrm>
            <a:off x="6200251" y="108179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B</a:t>
            </a:r>
          </a:p>
        </p:txBody>
      </p:sp>
      <p:sp>
        <p:nvSpPr>
          <p:cNvPr id="38" name="Text Box 26"/>
          <p:cNvSpPr txBox="1">
            <a:spLocks noChangeAspect="1" noChangeArrowheads="1"/>
          </p:cNvSpPr>
          <p:nvPr/>
        </p:nvSpPr>
        <p:spPr bwMode="auto">
          <a:xfrm>
            <a:off x="12024" y="1563887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C</a:t>
            </a:r>
          </a:p>
        </p:txBody>
      </p:sp>
      <p:sp>
        <p:nvSpPr>
          <p:cNvPr id="39" name="Text Box 26"/>
          <p:cNvSpPr txBox="1">
            <a:spLocks noChangeAspect="1" noChangeArrowheads="1"/>
          </p:cNvSpPr>
          <p:nvPr/>
        </p:nvSpPr>
        <p:spPr bwMode="auto">
          <a:xfrm>
            <a:off x="4281364" y="1767488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D</a:t>
            </a:r>
          </a:p>
        </p:txBody>
      </p:sp>
      <p:sp>
        <p:nvSpPr>
          <p:cNvPr id="40" name="Text Box 26"/>
          <p:cNvSpPr txBox="1">
            <a:spLocks noChangeAspect="1" noChangeArrowheads="1"/>
          </p:cNvSpPr>
          <p:nvPr/>
        </p:nvSpPr>
        <p:spPr bwMode="auto">
          <a:xfrm>
            <a:off x="10312202" y="1718713"/>
            <a:ext cx="343492" cy="6187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lIns="61625" tIns="32045" rIns="61625" bIns="32045">
            <a:spAutoFit/>
          </a:bodyPr>
          <a:lstStyle>
            <a:lvl1pPr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defTabSz="457200" eaLnBrk="0" hangingPunct="0"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tabLst>
                <a:tab pos="0" algn="l"/>
                <a:tab pos="914400" algn="l"/>
                <a:tab pos="1828800" algn="l"/>
                <a:tab pos="2743200" algn="l"/>
                <a:tab pos="3657600" algn="l"/>
                <a:tab pos="4572000" algn="l"/>
                <a:tab pos="5486400" algn="l"/>
                <a:tab pos="6400800" algn="l"/>
                <a:tab pos="7315200" algn="l"/>
                <a:tab pos="8229600" algn="l"/>
                <a:tab pos="9144000" algn="l"/>
                <a:tab pos="10058400" algn="l"/>
              </a:tabLs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>
              <a:spcBef>
                <a:spcPts val="1028"/>
              </a:spcBef>
              <a:buSzPct val="100000"/>
            </a:pPr>
            <a:r>
              <a:rPr lang="en-US" sz="3600" dirty="0" smtClean="0">
                <a:solidFill>
                  <a:srgbClr val="000000"/>
                </a:solidFill>
                <a:ea typeface="Arial Unicode MS" pitchFamily="34" charset="-128"/>
                <a:cs typeface="Arial Unicode MS" pitchFamily="34" charset="-128"/>
              </a:rPr>
              <a:t>F</a:t>
            </a:r>
            <a:endParaRPr lang="en-US" sz="3600" dirty="0">
              <a:solidFill>
                <a:srgbClr val="000000"/>
              </a:solidFill>
              <a:ea typeface="Arial Unicode MS" pitchFamily="34" charset="-128"/>
              <a:cs typeface="Arial Unicode MS" pitchFamily="34" charset="-128"/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11047236" y="2467847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ym typeface="Symbol" panose="05050102010706020507" pitchFamily="18" charset="2"/>
              </a:rPr>
              <a:t>***</a:t>
            </a:r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6222738" y="1776692"/>
            <a:ext cx="492444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spcBef>
                <a:spcPts val="1028"/>
              </a:spcBef>
              <a:buSzPct val="100000"/>
            </a:pPr>
            <a:r>
              <a:rPr lang="en-US" sz="3600" dirty="0" smtClean="0">
                <a:solidFill>
                  <a:srgbClr val="000000"/>
                </a:solidFill>
                <a:latin typeface="Arial" panose="020B0604020202020204" pitchFamily="34" charset="0"/>
                <a:ea typeface="Arial Unicode MS" pitchFamily="34" charset="-128"/>
                <a:cs typeface="Arial" panose="020B0604020202020204" pitchFamily="34" charset="0"/>
              </a:rPr>
              <a:t>E</a:t>
            </a:r>
            <a:endParaRPr lang="en-US" sz="3600" dirty="0">
              <a:solidFill>
                <a:srgbClr val="000000"/>
              </a:solidFill>
              <a:latin typeface="Arial" panose="020B0604020202020204" pitchFamily="34" charset="0"/>
              <a:ea typeface="Arial Unicode MS" pitchFamily="34" charset="-128"/>
              <a:cs typeface="Arial" panose="020B0604020202020204" pitchFamily="34" charset="0"/>
            </a:endParaRPr>
          </a:p>
        </p:txBody>
      </p:sp>
      <p:cxnSp>
        <p:nvCxnSpPr>
          <p:cNvPr id="43" name="Straight Connector 42"/>
          <p:cNvCxnSpPr/>
          <p:nvPr/>
        </p:nvCxnSpPr>
        <p:spPr>
          <a:xfrm flipV="1">
            <a:off x="10935385" y="2759757"/>
            <a:ext cx="736996" cy="1161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2328" y="5336313"/>
            <a:ext cx="1210612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5. Effects of P-cadherin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verexpression on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roliferation, adhesion and spreading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of colon cancer cell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Immunoblotting analysis shows the level of P-cadherin protein in control an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-overexpressing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W620 cells.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Cell count for control an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-overexpressing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W620 cells at different time intervals after plating. Means ± SE (n=3).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,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 Adhesion of control an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-overexpressing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W620 on collagen I matrix and (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,F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) cell spreading on the collagen I matrix was examined 1 h after plating. Means ± SE (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n=9 fields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d 100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cells for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ell attachment and cell spreading assays, respectively);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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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0.005. Scale bars, 100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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</a:p>
        </p:txBody>
      </p:sp>
      <p:cxnSp>
        <p:nvCxnSpPr>
          <p:cNvPr id="45" name="Straight Connector 44"/>
          <p:cNvCxnSpPr/>
          <p:nvPr/>
        </p:nvCxnSpPr>
        <p:spPr>
          <a:xfrm>
            <a:off x="3285338" y="4580682"/>
            <a:ext cx="33469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29">
            <a:extLst>
              <a:ext uri="{FF2B5EF4-FFF2-40B4-BE49-F238E27FC236}">
                <a16:creationId xmlns:a16="http://schemas.microsoft.com/office/drawing/2014/main" xmlns="" id="{DFBFF3B5-A2E0-466D-BA71-E71CAA1D3A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14649" y="1866333"/>
            <a:ext cx="152304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Times New Roman" panose="02020603050405020304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Times New Roman" panose="02020603050405020304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Times New Roman" panose="02020603050405020304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Times New Roman" panose="02020603050405020304" pitchFamily="18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Time (days)</a:t>
            </a:r>
            <a:endParaRPr lang="en-US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7" name="Object 4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7003229"/>
              </p:ext>
            </p:extLst>
          </p:nvPr>
        </p:nvGraphicFramePr>
        <p:xfrm>
          <a:off x="3974920" y="2482737"/>
          <a:ext cx="2091370" cy="2099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79" name="Prism 9" r:id="rId16" imgW="2076543" imgH="2453009" progId="Prism9.Document">
                  <p:embed/>
                </p:oleObj>
              </mc:Choice>
              <mc:Fallback>
                <p:oleObj name="Prism 9" r:id="rId16" imgW="2076543" imgH="245300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974920" y="2482737"/>
                        <a:ext cx="2091370" cy="209936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TextBox 48"/>
          <p:cNvSpPr txBox="1"/>
          <p:nvPr/>
        </p:nvSpPr>
        <p:spPr>
          <a:xfrm rot="16200000">
            <a:off x="2751374" y="3262134"/>
            <a:ext cx="2390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Number of cells/field 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4722789" y="2400547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ym typeface="Symbol" panose="05050102010706020507" pitchFamily="18" charset="2"/>
              </a:rPr>
              <a:t>***</a:t>
            </a:r>
            <a:endParaRPr lang="en-US" dirty="0"/>
          </a:p>
        </p:txBody>
      </p:sp>
      <p:cxnSp>
        <p:nvCxnSpPr>
          <p:cNvPr id="51" name="Straight Connector 50"/>
          <p:cNvCxnSpPr/>
          <p:nvPr/>
        </p:nvCxnSpPr>
        <p:spPr>
          <a:xfrm flipV="1">
            <a:off x="4572480" y="2675808"/>
            <a:ext cx="736996" cy="11611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8115630" y="4762964"/>
            <a:ext cx="18865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</a:t>
            </a:r>
            <a:r>
              <a:rPr lang="en-US" dirty="0" smtClean="0"/>
              <a:t> 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P-cadherin overexpressio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670875" y="4811334"/>
            <a:ext cx="959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72555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3</TotalTime>
  <Words>164</Words>
  <Application>Microsoft Office PowerPoint</Application>
  <PresentationFormat>Widescreen</PresentationFormat>
  <Paragraphs>2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 Unicode MS</vt:lpstr>
      <vt:lpstr>Arial</vt:lpstr>
      <vt:lpstr>Calibri</vt:lpstr>
      <vt:lpstr>Calibri Light</vt:lpstr>
      <vt:lpstr>Symbol</vt:lpstr>
      <vt:lpstr>Office Theme</vt:lpstr>
      <vt:lpstr>Prism 9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, Lei</dc:creator>
  <cp:lastModifiedBy>Ivanov, Andrei</cp:lastModifiedBy>
  <cp:revision>68</cp:revision>
  <cp:lastPrinted>2022-03-30T14:49:45Z</cp:lastPrinted>
  <dcterms:created xsi:type="dcterms:W3CDTF">2018-08-30T17:59:33Z</dcterms:created>
  <dcterms:modified xsi:type="dcterms:W3CDTF">2022-04-20T13:14:01Z</dcterms:modified>
</cp:coreProperties>
</file>